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99"/>
    <a:srgbClr val="FFCCFF"/>
    <a:srgbClr val="FFC000"/>
    <a:srgbClr val="70AD47"/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48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207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0424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623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8210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4151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6568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187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8246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5162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83865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0288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1141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025EF4-917E-48DD-965E-593A6E260249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1A9629-5EAD-46CD-80CE-4DADE4D8130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13344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스크린샷이(가) 표시된 사진&#10;&#10;자동 생성된 설명">
            <a:extLst>
              <a:ext uri="{FF2B5EF4-FFF2-40B4-BE49-F238E27FC236}">
                <a16:creationId xmlns:a16="http://schemas.microsoft.com/office/drawing/2014/main" id="{8C658992-9610-4283-B436-F5559338D8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099" y="704079"/>
            <a:ext cx="7351801" cy="5449842"/>
          </a:xfrm>
          <a:prstGeom prst="rect">
            <a:avLst/>
          </a:prstGeom>
        </p:spPr>
      </p:pic>
      <p:sp>
        <p:nvSpPr>
          <p:cNvPr id="5" name="직사각형 4">
            <a:extLst>
              <a:ext uri="{FF2B5EF4-FFF2-40B4-BE49-F238E27FC236}">
                <a16:creationId xmlns:a16="http://schemas.microsoft.com/office/drawing/2014/main" id="{80B25D12-B6C5-4D60-894F-1F3DDA4ED884}"/>
              </a:ext>
            </a:extLst>
          </p:cNvPr>
          <p:cNvSpPr/>
          <p:nvPr/>
        </p:nvSpPr>
        <p:spPr>
          <a:xfrm>
            <a:off x="0" y="6278654"/>
            <a:ext cx="9144000" cy="548276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just"/>
            <a:r>
              <a:rPr lang="en-US" altLang="ko-KR" sz="1000" b="1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. Comparison of small RNA mapping analyses within the phylogenetic context of nine representative CHS genes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gray ribbons denote the genomic regions of perfect matches longer than 20 bps between the neighboring CHS genes. The gene sizes and positions of exon/intron junctions are all drawn to scale, while the read depth to the logarithmic scale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9311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52</TotalTime>
  <Words>64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진현 김</dc:creator>
  <cp:lastModifiedBy>김 진현</cp:lastModifiedBy>
  <cp:revision>53</cp:revision>
  <dcterms:created xsi:type="dcterms:W3CDTF">2019-06-13T12:09:49Z</dcterms:created>
  <dcterms:modified xsi:type="dcterms:W3CDTF">2020-04-24T15:39:41Z</dcterms:modified>
</cp:coreProperties>
</file>